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3B76D2E-E496-475B-BED9-129FF509E07C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8ECC93F-572D-4858-B942-A63F6C1E2E0E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58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24EED0-7C3D-4817-8C04-0655CDBD26D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4EF1A5-105D-4DBC-8379-A2D3067F89D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3965DC-B9C0-4967-A649-E14C61B3BAE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404074-1076-4E9D-9550-31CFE6586CA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334231-612E-49CF-975E-4C9CEA0FE40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BA2E53-0A78-4A22-9BF4-6ABC11EB7B3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B6FF38-BCCB-4330-B3E0-D3894A909C2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0BDEA4-849B-42F3-A68D-F23FBA6D4F3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F989B3-40A1-4C68-9061-40782F48720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84DD3C-E38E-4495-96FE-A6549A3EA4B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FBFF95-1FA2-442A-A6A0-2E5131FE66B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AF1305-031C-4D29-AA85-69DD03AC39F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7269B1F-76DB-4127-8411-C3415544C97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3" descr=""/>
          <p:cNvPicPr/>
          <p:nvPr/>
        </p:nvPicPr>
        <p:blipFill>
          <a:blip r:embed="rId1"/>
          <a:srcRect l="0" t="8076" r="0" b="0"/>
          <a:stretch/>
        </p:blipFill>
        <p:spPr>
          <a:xfrm>
            <a:off x="762120" y="2438280"/>
            <a:ext cx="3382920" cy="213228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2" descr=""/>
          <p:cNvPicPr/>
          <p:nvPr/>
        </p:nvPicPr>
        <p:blipFill>
          <a:blip r:embed="rId2"/>
          <a:srcRect l="0" t="7579" r="0" b="0"/>
          <a:stretch/>
        </p:blipFill>
        <p:spPr>
          <a:xfrm>
            <a:off x="4495680" y="2438280"/>
            <a:ext cx="3382920" cy="2143080"/>
          </a:xfrm>
          <a:prstGeom prst="rect">
            <a:avLst/>
          </a:prstGeom>
          <a:ln w="0">
            <a:noFill/>
          </a:ln>
        </p:spPr>
      </p:pic>
      <p:sp>
        <p:nvSpPr>
          <p:cNvPr id="50" name="Text Box 6"/>
          <p:cNvSpPr/>
          <p:nvPr/>
        </p:nvSpPr>
        <p:spPr>
          <a:xfrm>
            <a:off x="2424240" y="468468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7"/>
          <p:cNvSpPr/>
          <p:nvPr/>
        </p:nvSpPr>
        <p:spPr>
          <a:xfrm>
            <a:off x="6402600" y="472428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9"/>
          <p:cNvSpPr/>
          <p:nvPr/>
        </p:nvSpPr>
        <p:spPr>
          <a:xfrm>
            <a:off x="457200" y="5541840"/>
            <a:ext cx="83977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l S3. Example spectra for an analyses with low background and acceptable (A) ion ratios, unacceptable (B) ion ratios due to high baseline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Line 10"/>
          <p:cNvSpPr/>
          <p:nvPr/>
        </p:nvSpPr>
        <p:spPr>
          <a:xfrm flipH="1">
            <a:off x="3048120" y="1371600"/>
            <a:ext cx="1371600" cy="12193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Line 11"/>
          <p:cNvSpPr/>
          <p:nvPr/>
        </p:nvSpPr>
        <p:spPr>
          <a:xfrm>
            <a:off x="4419720" y="1371600"/>
            <a:ext cx="2286000" cy="16765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12"/>
          <p:cNvSpPr/>
          <p:nvPr/>
        </p:nvSpPr>
        <p:spPr>
          <a:xfrm>
            <a:off x="4039560" y="990720"/>
            <a:ext cx="766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IGF-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9-30T20:54:23Z</dcterms:created>
  <dc:creator>cory.e.bystrom</dc:creator>
  <dc:description/>
  <dc:language>en-US</dc:language>
  <cp:lastModifiedBy>Cory Bystrom</cp:lastModifiedBy>
  <dcterms:modified xsi:type="dcterms:W3CDTF">2012-08-12T21:07:14Z</dcterms:modified>
  <cp:revision>3</cp:revision>
  <dc:subject/>
  <dc:title>Slide 1</dc:title>
</cp:coreProperties>
</file>